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1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5: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overall prevalence of antimicrobial resistance genes (ARGs). B) Prevalence of 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-level multi-resistance (resistance to ≥ 3 antimicrobial classes) per sample type per time-point. Bars represent 95% confidence interval (CI)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03D91FED-7E3C-497D-B631-1905C5588F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5560133"/>
              </p:ext>
            </p:extLst>
          </p:nvPr>
        </p:nvGraphicFramePr>
        <p:xfrm>
          <a:off x="144708" y="1901579"/>
          <a:ext cx="5602169" cy="30516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10" r:id="rId3" imgW="6778114" imgH="3693003" progId="Prism10.Document">
                  <p:embed/>
                </p:oleObj>
              </mc:Choice>
              <mc:Fallback>
                <p:oleObj name="Prism 10" r:id="rId3" imgW="6778114" imgH="369300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4708" y="1901579"/>
                        <a:ext cx="5602169" cy="30516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84CE0AD-7AD0-4F36-8CCF-753C4A4AEE28}"/>
              </a:ext>
            </a:extLst>
          </p:cNvPr>
          <p:cNvSpPr txBox="1"/>
          <p:nvPr/>
        </p:nvSpPr>
        <p:spPr>
          <a:xfrm>
            <a:off x="172720" y="1694364"/>
            <a:ext cx="139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0EEC4461-C21B-4CB8-84D2-1D3A50DC98CA}"/>
              </a:ext>
            </a:extLst>
          </p:cNvPr>
          <p:cNvSpPr txBox="1"/>
          <p:nvPr/>
        </p:nvSpPr>
        <p:spPr>
          <a:xfrm>
            <a:off x="6664960" y="1694364"/>
            <a:ext cx="139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grpSp>
        <p:nvGrpSpPr>
          <p:cNvPr id="15" name="Gruppo 14">
            <a:extLst>
              <a:ext uri="{FF2B5EF4-FFF2-40B4-BE49-F238E27FC236}">
                <a16:creationId xmlns:a16="http://schemas.microsoft.com/office/drawing/2014/main" id="{6F02E87F-07ED-4E69-B403-A134A4D86BB2}"/>
              </a:ext>
            </a:extLst>
          </p:cNvPr>
          <p:cNvGrpSpPr/>
          <p:nvPr/>
        </p:nvGrpSpPr>
        <p:grpSpPr>
          <a:xfrm>
            <a:off x="7594600" y="1974023"/>
            <a:ext cx="4048745" cy="2885315"/>
            <a:chOff x="7594600" y="1974023"/>
            <a:chExt cx="4048745" cy="2885315"/>
          </a:xfrm>
        </p:grpSpPr>
        <p:graphicFrame>
          <p:nvGraphicFramePr>
            <p:cNvPr id="9" name="Oggetto 8">
              <a:extLst>
                <a:ext uri="{FF2B5EF4-FFF2-40B4-BE49-F238E27FC236}">
                  <a16:creationId xmlns:a16="http://schemas.microsoft.com/office/drawing/2014/main" id="{766A9564-806C-44B9-8E9A-05F52657D38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77043030"/>
                </p:ext>
              </p:extLst>
            </p:nvPr>
          </p:nvGraphicFramePr>
          <p:xfrm>
            <a:off x="7594600" y="2047875"/>
            <a:ext cx="3163888" cy="2811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7" name="Prism 10" r:id="rId5" imgW="3898469" imgH="3466174" progId="Prism10.Document">
                    <p:embed/>
                  </p:oleObj>
                </mc:Choice>
                <mc:Fallback>
                  <p:oleObj name="Prism 10" r:id="rId5" imgW="3898469" imgH="3466174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594600" y="2047875"/>
                          <a:ext cx="3163888" cy="28114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0F0144DB-DE7D-4F39-B7B0-3CAC1DB7D9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2027" t="3048" b="55302"/>
            <a:stretch/>
          </p:blipFill>
          <p:spPr>
            <a:xfrm>
              <a:off x="10879187" y="1974023"/>
              <a:ext cx="764158" cy="161236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4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ism 10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22</cp:revision>
  <dcterms:created xsi:type="dcterms:W3CDTF">2022-03-15T12:01:40Z</dcterms:created>
  <dcterms:modified xsi:type="dcterms:W3CDTF">2024-07-02T09:40:02Z</dcterms:modified>
</cp:coreProperties>
</file>